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96" y="2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D29A0B-7502-4C34-8B64-7B0167DEC8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BDA78D-6CE1-4C9D-AB69-1773D032A6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510A27-690C-46AA-883E-0A198FB6BF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29AFB5-1F07-49F6-A20D-DC4347C54D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42C903-58CF-421D-97CC-5471D9AC4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631221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68956D-6483-496D-A2BF-3FC9B360C0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06FAD3-2FB6-42B5-AB54-8228368B4D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446828-FEE2-45F9-AD30-59EA9B4580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E8361D-28F0-42E7-82B4-966D1F813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AACEB2-A79A-4DF3-9909-3E118F6176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760630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09D4490-3136-405A-9F55-2CB0B68362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4383D6B-C7E2-4FF1-8D90-1C12DA2FD3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C3A606-1A06-4707-BCA2-E2E3464078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2EA943-15CC-402A-897E-F49AEEA69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89CEC3-AD51-4B03-9641-91C5AC55B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452061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D0EE11-5D4B-4C01-8668-34C8A759CF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5BBA3D-2DA2-4B68-AA6C-AD48D4420D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035D7E-DE89-4701-B12F-3E59069115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E56511-E2BE-46A1-8C99-F232AA9285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347366-8CA4-4069-991C-08D35AF850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37537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B78C3A-A44D-4452-86DE-11FD3BAF46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F9C91B-9110-4051-B8AA-85275D743E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61EB4C-A28D-4310-AB98-B6DDA3F7FA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B6F33B-F4FF-4430-A0B9-C9B55EC5B0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BC9752-9D3A-4099-AE5E-ACEE279A0A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44988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37CF90-7B51-4F43-9B3A-CF91CCCBB2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4F48BD-833C-4155-AE2B-ACA80596CB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BADB13-7E25-4FE4-8005-8B56CB69E5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BA131B-5474-474D-9FF2-ABF41CF597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14088C-4A56-4B83-8ECE-BB45410159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8306AC-378C-4D66-A700-DFDE7B9EF2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88336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076436-549C-46CE-AA85-885D1184C0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0EEBD4-D70D-4E7C-9349-0FB7C5C21B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788115-D67E-4975-BA40-934C981C01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23CB290-301F-4A6C-B3A3-3D073CC1C8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E3F7A5C-804F-49D5-978D-C220F23D62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3E929C9-A663-4AF4-ACE8-35B8FD727A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57B7BF8-5DD7-4045-9BEF-26AD1CBE3F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F309E2A-F02A-4A74-B8AD-6DC524C574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03088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9C408F-40A9-4205-A5A9-4443A6612F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C3E5E6E-A8F0-4AEF-942B-2159C92F7E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1CB337A-99C9-4AF9-BC84-440DA73F3B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E7A497-B536-4F7C-AD80-50266C9BC3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596164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22C5D6A-4E55-49E1-8038-67915A7276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5E68755-216B-4349-8F27-A794799D61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9E95D88-2AC0-4C49-B028-8695DF19DF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96159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D8B9F9-6935-4A4B-933D-4204A099AA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45E56F-761F-48F5-81E5-815DD458A0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4257B29-6F33-4F8C-9FF6-BD925AAB2C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7821E1-064B-48E1-9F9F-21F4B46A87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BDC815-0ECF-4D01-B834-49A6822AC6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F6A687-31DC-44E5-8A73-B94B3227F6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85648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29D5F6-906B-4D74-92BD-E41E4B1F8A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6E3B82-4432-4BE7-97D1-69EF153ED1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8346A93-B252-445F-86DD-9545381157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66BD90-6C07-49C7-99C5-49F78988D7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A1E382-2F9F-43A1-B09A-9BF42249C1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C0C73D-CF04-4A22-9FBC-7A671DDE05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6847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354D4BB-DCD7-424C-8752-ADD42092E4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B80E32-E933-4445-B546-295DEE1133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68E516-3966-49ED-AF84-64604C62CE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4F7858-F18D-42F1-97E6-A6C4D36AA9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A7E24C-E517-466E-A77E-CC5EDE51B9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363356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2.jp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3E7ADC43-7E46-4333-8EF8-9EC1497A731E}"/>
              </a:ext>
            </a:extLst>
          </p:cNvPr>
          <p:cNvGrpSpPr/>
          <p:nvPr/>
        </p:nvGrpSpPr>
        <p:grpSpPr>
          <a:xfrm>
            <a:off x="809940" y="624031"/>
            <a:ext cx="4741967" cy="5148273"/>
            <a:chOff x="703408" y="624031"/>
            <a:chExt cx="4741967" cy="5148273"/>
          </a:xfrm>
        </p:grpSpPr>
        <p:pic>
          <p:nvPicPr>
            <p:cNvPr id="4" name="221 GEN 2 ug BV6160">
              <a:hlinkClick r:id="" action="ppaction://media"/>
              <a:extLst>
                <a:ext uri="{FF2B5EF4-FFF2-40B4-BE49-F238E27FC236}">
                  <a16:creationId xmlns:a16="http://schemas.microsoft.com/office/drawing/2014/main" id="{1D63A73A-D457-43B1-B1EA-95A6410BA432}"/>
                </a:ext>
              </a:extLst>
            </p:cNvPr>
            <p:cNvPicPr>
              <a:picLocks noChangeAspect="1"/>
            </p:cNvPicPr>
            <p:nvPr>
              <a:videoFile r:link="rId2"/>
              <p:extLst>
                <p:ext uri="{DAA4B4D4-6D71-4841-9C94-3DE7FCFB9230}">
                  <p14:media xmlns:p14="http://schemas.microsoft.com/office/powerpoint/2010/main" r:embed="rId1"/>
                </p:ext>
              </p:extLst>
            </p:nvPr>
          </p:nvPicPr>
          <p:blipFill>
            <a:blip r:embed="rId4"/>
            <a:stretch>
              <a:fillRect/>
            </a:stretch>
          </p:blipFill>
          <p:spPr>
            <a:xfrm rot="10800000">
              <a:off x="703410" y="624031"/>
              <a:ext cx="4596288" cy="1894772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70F5A23E-0957-4953-8042-A80208DC6CE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0800000">
              <a:off x="703409" y="2740163"/>
              <a:ext cx="4627188" cy="1795118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55EB92D-8ABD-495B-BC8B-22D7D20BEC9E}"/>
                </a:ext>
              </a:extLst>
            </p:cNvPr>
            <p:cNvSpPr txBox="1"/>
            <p:nvPr/>
          </p:nvSpPr>
          <p:spPr>
            <a:xfrm>
              <a:off x="703408" y="4756641"/>
              <a:ext cx="4741967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I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vie S4</a:t>
              </a:r>
              <a:r>
                <a:rPr lang="sv-SE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ample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-lapse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ovie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f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ixed species in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crofluidic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hip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rowing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n MH media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ed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 antibiotic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entamicin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op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nd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spective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ISH image (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ottom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.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his movie is generated from the time-lapse phase contrast images with time intervals of 120 sec and playback speed of the video is 5 fps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945524551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58</Words>
  <Application>Microsoft Office PowerPoint</Application>
  <PresentationFormat>Widescreen</PresentationFormat>
  <Paragraphs>1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nodh Kandavalli</dc:creator>
  <cp:lastModifiedBy>Vinodh Kandavalli</cp:lastModifiedBy>
  <cp:revision>17</cp:revision>
  <dcterms:created xsi:type="dcterms:W3CDTF">2021-08-13T05:45:58Z</dcterms:created>
  <dcterms:modified xsi:type="dcterms:W3CDTF">2022-09-21T11:45:16Z</dcterms:modified>
</cp:coreProperties>
</file>